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custDataLst>
    <p:tags r:id="rId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1BFA1E7-BB4A-DC93-A343-216D039E1850}" name="Michaela Cvanová" initials="MC" userId="S::175578@muni.cz::0223553e-aaee-476b-a3df-411cbe18005f" providerId="AD"/>
  <p188:author id="{E8EE93F0-1532-C8DC-CB41-C204214A2B8E}" name="Petra Bořilová Linhartová" initials="PL" userId="S::106107@muni.cz::46909d2b-9e59-4fa0-9fb9-5f8fcf5e1c3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DD5D5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0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s-CZ"/>
              <a:t>Kliknutím můžet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32644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54960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81894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06156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40233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44590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378195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60387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80804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5892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s-CZ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043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3C6E7D-796E-4E6C-9440-3A2DD28AA999}" type="datetimeFigureOut">
              <a:rPr lang="cs-CZ" smtClean="0"/>
              <a:t>19.07.2022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0DB84B-D676-4723-9EDE-515B4A09548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6212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Skupina 5"/>
          <p:cNvGrpSpPr/>
          <p:nvPr/>
        </p:nvGrpSpPr>
        <p:grpSpPr>
          <a:xfrm>
            <a:off x="0" y="0"/>
            <a:ext cx="6556680" cy="9906000"/>
            <a:chOff x="0" y="0"/>
            <a:chExt cx="6556680" cy="9906000"/>
          </a:xfrm>
        </p:grpSpPr>
        <p:sp>
          <p:nvSpPr>
            <p:cNvPr id="4" name="Obdélník 3">
              <a:extLst>
                <a:ext uri="{FF2B5EF4-FFF2-40B4-BE49-F238E27FC236}">
                  <a16:creationId xmlns:a16="http://schemas.microsoft.com/office/drawing/2014/main" id="{A075E278-6EC9-B460-F559-87615D3CB1C7}"/>
                </a:ext>
              </a:extLst>
            </p:cNvPr>
            <p:cNvSpPr/>
            <p:nvPr/>
          </p:nvSpPr>
          <p:spPr>
            <a:xfrm>
              <a:off x="436723" y="344650"/>
              <a:ext cx="6119957" cy="38253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9">
              <a:extLst>
                <a:ext uri="{FF2B5EF4-FFF2-40B4-BE49-F238E27FC236}">
                  <a16:creationId xmlns:a16="http://schemas.microsoft.com/office/drawing/2014/main" id="{C30940D6-5973-497B-B521-15FF2B0FE451}"/>
                </a:ext>
              </a:extLst>
            </p:cNvPr>
            <p:cNvSpPr txBox="1"/>
            <p:nvPr/>
          </p:nvSpPr>
          <p:spPr>
            <a:xfrm>
              <a:off x="540145" y="429501"/>
              <a:ext cx="5760000" cy="1440000"/>
            </a:xfrm>
            <a:prstGeom prst="rect">
              <a:avLst/>
            </a:prstGeom>
            <a:solidFill>
              <a:srgbClr val="0000FF">
                <a:alpha val="12000"/>
              </a:srgbClr>
            </a:solidFill>
            <a:ln cmpd="dbl">
              <a:noFill/>
              <a:prstDash val="sys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tic</a:t>
              </a:r>
              <a:r>
                <a:rPr lang="cs-CZ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sociation</a:t>
              </a:r>
              <a:r>
                <a:rPr lang="cs-CZ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tudy</a:t>
              </a: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Obdélník 1">
              <a:extLst>
                <a:ext uri="{FF2B5EF4-FFF2-40B4-BE49-F238E27FC236}">
                  <a16:creationId xmlns:a16="http://schemas.microsoft.com/office/drawing/2014/main" id="{FF3FB9D7-B359-0B43-94A6-CE71399F397E}"/>
                </a:ext>
              </a:extLst>
            </p:cNvPr>
            <p:cNvSpPr/>
            <p:nvPr/>
          </p:nvSpPr>
          <p:spPr>
            <a:xfrm>
              <a:off x="322928" y="0"/>
              <a:ext cx="6120000" cy="9906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B7E9C97-08CF-4DA3-A0DA-EE6EAD0FAA4F}"/>
                </a:ext>
              </a:extLst>
            </p:cNvPr>
            <p:cNvSpPr txBox="1"/>
            <p:nvPr/>
          </p:nvSpPr>
          <p:spPr>
            <a:xfrm>
              <a:off x="0" y="0"/>
              <a:ext cx="17604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3" name="Rectangle 1">
              <a:extLst>
                <a:ext uri="{FF2B5EF4-FFF2-40B4-BE49-F238E27FC236}">
                  <a16:creationId xmlns:a16="http://schemas.microsoft.com/office/drawing/2014/main" id="{3FB8152B-2936-2592-554C-B4161F1293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720" y="7664034"/>
              <a:ext cx="5760001" cy="12003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algn="just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cs-CZ" sz="1200" b="1" i="0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Figure </a:t>
              </a:r>
              <a:r>
                <a:rPr kumimoji="0" lang="cs-CZ" altLang="cs-CZ" sz="1200" b="1" i="0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  <a:r>
                <a:rPr kumimoji="0" lang="en-GB" altLang="cs-CZ" sz="1200" b="1" i="0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. </a:t>
              </a:r>
              <a:r>
                <a:rPr lang="cs-CZ" altLang="cs-CZ" sz="1200" dirty="0" err="1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en-GB" altLang="cs-CZ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flowchart of analyses performed</a:t>
              </a:r>
              <a:r>
                <a:rPr lang="cs-CZ" altLang="cs-CZ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in </a:t>
              </a:r>
              <a:r>
                <a:rPr lang="cs-CZ" altLang="cs-CZ" sz="1200" dirty="0" err="1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this</a:t>
              </a:r>
              <a:r>
                <a:rPr lang="cs-CZ" altLang="cs-CZ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study</a:t>
              </a:r>
            </a:p>
            <a:p>
              <a:pPr algn="just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=Barrett’s </a:t>
              </a:r>
              <a:r>
                <a:rPr lang="en-GB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sophagus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EAC=</a:t>
              </a:r>
              <a:r>
                <a:rPr lang="en-GB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sophageal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denocarcinoma; EGF=epidermal growth factor; EGFR=epidermal growth factor receptor; 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=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ealthy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s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RD=non-erosive reflux disease group; RE=reflux esophagitis</a:t>
              </a:r>
              <a:endParaRPr lang="cs-CZ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cs-CZ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endParaRPr kumimoji="0" lang="en-GB" altLang="cs-CZ" sz="12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altLang="cs-CZ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9">
              <a:extLst>
                <a:ext uri="{FF2B5EF4-FFF2-40B4-BE49-F238E27FC236}">
                  <a16:creationId xmlns:a16="http://schemas.microsoft.com/office/drawing/2014/main" id="{6355B633-8691-4B0D-8704-D83C95084BAA}"/>
                </a:ext>
              </a:extLst>
            </p:cNvPr>
            <p:cNvSpPr txBox="1"/>
            <p:nvPr/>
          </p:nvSpPr>
          <p:spPr>
            <a:xfrm>
              <a:off x="1147122" y="2495047"/>
              <a:ext cx="4579474" cy="2677656"/>
            </a:xfrm>
            <a:prstGeom prst="rect">
              <a:avLst/>
            </a:prstGeom>
            <a:solidFill>
              <a:schemeClr val="accent6">
                <a:lumMod val="20000"/>
                <a:lumOff val="80000"/>
              </a:schemeClr>
            </a:solidFill>
            <a:ln cmpd="dbl">
              <a:solidFill>
                <a:schemeClr val="bg1"/>
              </a:solidFill>
              <a:prstDash val="sys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</a:t>
              </a:r>
              <a:r>
                <a:rPr lang="cs-CZ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</a:t>
              </a:r>
              <a:r>
                <a:rPr lang="cs-CZ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cs-CZ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/EGFR </a:t>
              </a:r>
              <a:r>
                <a:rPr lang="cs-CZ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RNA</a:t>
              </a:r>
              <a:r>
                <a:rPr lang="cs-CZ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ion</a:t>
              </a:r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8" name="Přímá spojnice se šipkou 77">
              <a:extLst>
                <a:ext uri="{FF2B5EF4-FFF2-40B4-BE49-F238E27FC236}">
                  <a16:creationId xmlns:a16="http://schemas.microsoft.com/office/drawing/2014/main" id="{209150D0-CEA7-40D7-BCA7-1320EEC14F16}"/>
                </a:ext>
              </a:extLst>
            </p:cNvPr>
            <p:cNvCxnSpPr/>
            <p:nvPr/>
          </p:nvCxnSpPr>
          <p:spPr>
            <a:xfrm>
              <a:off x="2169677" y="1596460"/>
              <a:ext cx="0" cy="124377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ovéPole 79">
              <a:extLst>
                <a:ext uri="{FF2B5EF4-FFF2-40B4-BE49-F238E27FC236}">
                  <a16:creationId xmlns:a16="http://schemas.microsoft.com/office/drawing/2014/main" id="{996F8A20-BCF3-4422-B608-0143F625AE9F}"/>
                </a:ext>
              </a:extLst>
            </p:cNvPr>
            <p:cNvSpPr txBox="1">
              <a:spLocks/>
            </p:cNvSpPr>
            <p:nvPr/>
          </p:nvSpPr>
          <p:spPr>
            <a:xfrm>
              <a:off x="1364338" y="4082155"/>
              <a:ext cx="1800000" cy="82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issues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ndoscopically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sible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ological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hanges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n=23)</a:t>
              </a:r>
            </a:p>
          </p:txBody>
        </p:sp>
        <p:sp>
          <p:nvSpPr>
            <p:cNvPr id="81" name="TextovéPole 80">
              <a:extLst>
                <a:ext uri="{FF2B5EF4-FFF2-40B4-BE49-F238E27FC236}">
                  <a16:creationId xmlns:a16="http://schemas.microsoft.com/office/drawing/2014/main" id="{CA0343D6-FE4E-4088-B840-E574838867AB}"/>
                </a:ext>
              </a:extLst>
            </p:cNvPr>
            <p:cNvSpPr txBox="1">
              <a:spLocks/>
            </p:cNvSpPr>
            <p:nvPr/>
          </p:nvSpPr>
          <p:spPr>
            <a:xfrm>
              <a:off x="3683469" y="4082155"/>
              <a:ext cx="1800000" cy="82800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issues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out</a:t>
              </a:r>
              <a:r>
                <a:rPr lang="cs-CZ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ndoscopically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sible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ological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hanges</a:t>
              </a: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n=23)</a:t>
              </a:r>
            </a:p>
          </p:txBody>
        </p:sp>
        <p:cxnSp>
          <p:nvCxnSpPr>
            <p:cNvPr id="41" name="Přímá spojnice se šipkou 40">
              <a:extLst>
                <a:ext uri="{FF2B5EF4-FFF2-40B4-BE49-F238E27FC236}">
                  <a16:creationId xmlns:a16="http://schemas.microsoft.com/office/drawing/2014/main" id="{FA14B320-9185-49FA-A441-15B0CC1307A6}"/>
                </a:ext>
              </a:extLst>
            </p:cNvPr>
            <p:cNvCxnSpPr>
              <a:cxnSpLocks/>
              <a:endCxn id="80" idx="0"/>
            </p:cNvCxnSpPr>
            <p:nvPr/>
          </p:nvCxnSpPr>
          <p:spPr>
            <a:xfrm flipH="1">
              <a:off x="2264338" y="3671718"/>
              <a:ext cx="1165339" cy="41043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Přímá spojnice se šipkou 83">
              <a:extLst>
                <a:ext uri="{FF2B5EF4-FFF2-40B4-BE49-F238E27FC236}">
                  <a16:creationId xmlns:a16="http://schemas.microsoft.com/office/drawing/2014/main" id="{E51E3221-916C-4549-BE40-A5803BD4E056}"/>
                </a:ext>
              </a:extLst>
            </p:cNvPr>
            <p:cNvCxnSpPr>
              <a:cxnSpLocks/>
              <a:stCxn id="30" idx="2"/>
              <a:endCxn id="81" idx="0"/>
            </p:cNvCxnSpPr>
            <p:nvPr/>
          </p:nvCxnSpPr>
          <p:spPr>
            <a:xfrm>
              <a:off x="3429677" y="3671718"/>
              <a:ext cx="1153792" cy="41043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9">
              <a:extLst>
                <a:ext uri="{FF2B5EF4-FFF2-40B4-BE49-F238E27FC236}">
                  <a16:creationId xmlns:a16="http://schemas.microsoft.com/office/drawing/2014/main" id="{651EA79A-9DAE-4749-B35F-1D01FA878F63}"/>
                </a:ext>
              </a:extLst>
            </p:cNvPr>
            <p:cNvSpPr txBox="1"/>
            <p:nvPr/>
          </p:nvSpPr>
          <p:spPr>
            <a:xfrm>
              <a:off x="552337" y="5776307"/>
              <a:ext cx="5760000" cy="1440000"/>
            </a:xfrm>
            <a:prstGeom prst="rect">
              <a:avLst/>
            </a:prstGeom>
            <a:solidFill>
              <a:srgbClr val="FDD5D5"/>
            </a:solidFill>
            <a:ln cmpd="dbl">
              <a:noFill/>
              <a:prstDash val="sysDash"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</a:t>
              </a:r>
              <a:r>
                <a:rPr lang="cs-CZ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s-CZ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cs-CZ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GF plasma </a:t>
              </a:r>
              <a:r>
                <a:rPr lang="cs-CZ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evels</a:t>
              </a:r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cs-CZ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ovéPole 21">
              <a:extLst>
                <a:ext uri="{FF2B5EF4-FFF2-40B4-BE49-F238E27FC236}">
                  <a16:creationId xmlns:a16="http://schemas.microsoft.com/office/drawing/2014/main" id="{E895CC38-AA9D-489F-B590-304CC03D1035}"/>
                </a:ext>
              </a:extLst>
            </p:cNvPr>
            <p:cNvSpPr txBox="1">
              <a:spLocks/>
            </p:cNvSpPr>
            <p:nvPr/>
          </p:nvSpPr>
          <p:spPr>
            <a:xfrm>
              <a:off x="818327" y="6125756"/>
              <a:ext cx="2520000" cy="82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1 (</a:t>
              </a:r>
              <a:r>
                <a:rPr lang="cs-CZ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s</a:t>
              </a:r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n=29):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 (n=10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 (n=9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C (n=10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ovéPole 22">
              <a:extLst>
                <a:ext uri="{FF2B5EF4-FFF2-40B4-BE49-F238E27FC236}">
                  <a16:creationId xmlns:a16="http://schemas.microsoft.com/office/drawing/2014/main" id="{6423FAB8-E1CB-47D7-ACC3-F7A8C8A880D5}"/>
                </a:ext>
              </a:extLst>
            </p:cNvPr>
            <p:cNvSpPr txBox="1">
              <a:spLocks/>
            </p:cNvSpPr>
            <p:nvPr/>
          </p:nvSpPr>
          <p:spPr>
            <a:xfrm>
              <a:off x="3541182" y="6125756"/>
              <a:ext cx="2520000" cy="82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2 (</a:t>
              </a:r>
              <a:r>
                <a:rPr lang="cs-CZ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s</a:t>
              </a:r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n=8):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 (n=8)</a:t>
              </a:r>
            </a:p>
            <a:p>
              <a:endParaRPr lang="cs-CZ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" name="Přímá spojnice se šipkou 23">
              <a:extLst>
                <a:ext uri="{FF2B5EF4-FFF2-40B4-BE49-F238E27FC236}">
                  <a16:creationId xmlns:a16="http://schemas.microsoft.com/office/drawing/2014/main" id="{863D6F45-3F7A-4513-83BD-1D2418D6A228}"/>
                </a:ext>
              </a:extLst>
            </p:cNvPr>
            <p:cNvCxnSpPr/>
            <p:nvPr/>
          </p:nvCxnSpPr>
          <p:spPr>
            <a:xfrm>
              <a:off x="880209" y="1453153"/>
              <a:ext cx="0" cy="467260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Přímá spojnice se šipkou 24">
              <a:extLst>
                <a:ext uri="{FF2B5EF4-FFF2-40B4-BE49-F238E27FC236}">
                  <a16:creationId xmlns:a16="http://schemas.microsoft.com/office/drawing/2014/main" id="{701EE57A-F055-4700-9373-EBBC1C464111}"/>
                </a:ext>
              </a:extLst>
            </p:cNvPr>
            <p:cNvCxnSpPr/>
            <p:nvPr/>
          </p:nvCxnSpPr>
          <p:spPr>
            <a:xfrm flipH="1">
              <a:off x="6003245" y="1460283"/>
              <a:ext cx="1" cy="465328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ovéPole 25">
              <a:extLst>
                <a:ext uri="{FF2B5EF4-FFF2-40B4-BE49-F238E27FC236}">
                  <a16:creationId xmlns:a16="http://schemas.microsoft.com/office/drawing/2014/main" id="{3DAB5272-FFDA-B0B9-7447-7C3CDB1801A9}"/>
                </a:ext>
              </a:extLst>
            </p:cNvPr>
            <p:cNvSpPr txBox="1">
              <a:spLocks/>
            </p:cNvSpPr>
            <p:nvPr/>
          </p:nvSpPr>
          <p:spPr>
            <a:xfrm>
              <a:off x="789656" y="756268"/>
              <a:ext cx="2520000" cy="82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1 (</a:t>
              </a:r>
              <a:r>
                <a:rPr lang="cs-CZ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s</a:t>
              </a:r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n=301):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 (n=161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 (n=92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C (n=48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ovéPole 28">
              <a:extLst>
                <a:ext uri="{FF2B5EF4-FFF2-40B4-BE49-F238E27FC236}">
                  <a16:creationId xmlns:a16="http://schemas.microsoft.com/office/drawing/2014/main" id="{3EBE2475-3F17-415B-9D1C-5B2E5CDEB056}"/>
                </a:ext>
              </a:extLst>
            </p:cNvPr>
            <p:cNvSpPr txBox="1">
              <a:spLocks/>
            </p:cNvSpPr>
            <p:nvPr/>
          </p:nvSpPr>
          <p:spPr>
            <a:xfrm>
              <a:off x="3536894" y="762262"/>
              <a:ext cx="2520000" cy="82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2 (</a:t>
              </a:r>
              <a:r>
                <a:rPr lang="cs-CZ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s</a:t>
              </a:r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n=106):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RD (n=98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 (n=8)</a:t>
              </a:r>
            </a:p>
            <a:p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ovéPole 29">
              <a:extLst>
                <a:ext uri="{FF2B5EF4-FFF2-40B4-BE49-F238E27FC236}">
                  <a16:creationId xmlns:a16="http://schemas.microsoft.com/office/drawing/2014/main" id="{317E2E06-EC84-48B7-BCB0-5EEF4756D0B9}"/>
                </a:ext>
              </a:extLst>
            </p:cNvPr>
            <p:cNvSpPr txBox="1">
              <a:spLocks/>
            </p:cNvSpPr>
            <p:nvPr/>
          </p:nvSpPr>
          <p:spPr>
            <a:xfrm>
              <a:off x="2169677" y="2843718"/>
              <a:ext cx="2520000" cy="82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1 (</a:t>
              </a:r>
              <a:r>
                <a:rPr lang="cs-CZ" sz="1200" b="1" u="sng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s</a:t>
              </a:r>
              <a:r>
                <a:rPr lang="cs-CZ" sz="12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n=23):</a:t>
              </a: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 (n=10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 (n=6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cs-CZ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C (n=7)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16642761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SLIDEFAB_CUSTOMSORTGLOBALLY" val="True"/>
</p:tagLst>
</file>

<file path=ppt/theme/theme1.xml><?xml version="1.0" encoding="utf-8"?>
<a:theme xmlns:a="http://schemas.openxmlformats.org/drawingml/2006/main" name="Office Them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>
          <a:solidFill>
            <a:schemeClr val="tx1"/>
          </a:solidFill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51</TotalTime>
  <Words>151</Words>
  <Application>Microsoft Office PowerPoint</Application>
  <PresentationFormat>A4 (210 × 297 mm)</PresentationFormat>
  <Paragraphs>44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Office Them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kovský Jiří RNDr. Ph.D.</dc:creator>
  <cp:lastModifiedBy>Petra Bořilová Linhartová</cp:lastModifiedBy>
  <cp:revision>50</cp:revision>
  <dcterms:created xsi:type="dcterms:W3CDTF">2022-03-31T06:58:06Z</dcterms:created>
  <dcterms:modified xsi:type="dcterms:W3CDTF">2022-07-19T15:59:37Z</dcterms:modified>
</cp:coreProperties>
</file>